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32EB284F-7949-FC44-AED4-8C4F679D9722}">
          <p14:sldIdLst>
            <p14:sldId id="291"/>
          </p14:sldIdLst>
        </p14:section>
      </p14:sectionLst>
    </p:ex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7F85FF"/>
    <a:srgbClr val="FC5653"/>
    <a:srgbClr val="FEA0A1"/>
    <a:srgbClr val="FD695A"/>
    <a:srgbClr val="9BADFF"/>
    <a:srgbClr val="495EFF"/>
    <a:srgbClr val="61FF58"/>
    <a:srgbClr val="84FF7D"/>
    <a:srgbClr val="22FF09"/>
    <a:srgbClr val="69C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067" autoAdjust="0"/>
    <p:restoredTop sz="92475" autoAdjust="0"/>
  </p:normalViewPr>
  <p:slideViewPr>
    <p:cSldViewPr snapToGrid="0" snapToObjects="1">
      <p:cViewPr>
        <p:scale>
          <a:sx n="201" d="100"/>
          <a:sy n="201" d="100"/>
        </p:scale>
        <p:origin x="-760" y="36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5368F-1C20-2147-933B-25F31BF077BE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157C04-4056-9946-94CB-039BCFF2D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0229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157C04-4056-9946-94CB-039BCFF2D2C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9863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20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563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275167"/>
            <a:ext cx="1543050" cy="585046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275167"/>
            <a:ext cx="4514850" cy="585046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48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8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37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03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21"/>
            <a:ext cx="303014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21"/>
            <a:ext cx="303133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985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079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16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9"/>
            <a:ext cx="2256235" cy="154940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34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352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07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genomevolution.org/CoGe/SynMap.pl" TargetMode="External"/><Relationship Id="rId4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09825" y="7529371"/>
            <a:ext cx="53062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l Figure S1 Whole-genome synteny map between </a:t>
            </a:r>
            <a:r>
              <a:rPr lang="en-US" sz="1200" i="1" dirty="0"/>
              <a:t>Setaria viridis </a:t>
            </a:r>
            <a:r>
              <a:rPr lang="en-US" sz="1200" dirty="0"/>
              <a:t>and </a:t>
            </a:r>
            <a:r>
              <a:rPr lang="en-US" sz="1200" i="1" dirty="0"/>
              <a:t>Setaria italica </a:t>
            </a:r>
            <a:r>
              <a:rPr lang="en-US" sz="1200" dirty="0"/>
              <a:t>by SynMap (</a:t>
            </a:r>
            <a:r>
              <a:rPr lang="en-US" sz="1200" dirty="0">
                <a:hlinkClick r:id="rId3"/>
              </a:rPr>
              <a:t>https://genomevolution.org/CoGe/SynMap.pl</a:t>
            </a:r>
            <a:r>
              <a:rPr lang="en-US" sz="1200" dirty="0"/>
              <a:t>). Each blue dot indicates a pair of best matching coding sequences identified by BLAST.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781650" y="7182353"/>
            <a:ext cx="16108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/>
              <a:t>Setaria</a:t>
            </a:r>
            <a:r>
              <a:rPr lang="en-US" sz="1200" i="1" dirty="0"/>
              <a:t> </a:t>
            </a:r>
            <a:r>
              <a:rPr lang="en-US" sz="1200" i="1" dirty="0" err="1"/>
              <a:t>italica</a:t>
            </a:r>
            <a:r>
              <a:rPr lang="en-US" sz="1200" i="1" dirty="0"/>
              <a:t> </a:t>
            </a:r>
            <a:r>
              <a:rPr lang="en-US" sz="1200" dirty="0"/>
              <a:t>scaffold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139903" y="6983190"/>
            <a:ext cx="2561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719450" y="6983190"/>
            <a:ext cx="2561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330289" y="6983190"/>
            <a:ext cx="2561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3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879177" y="6987037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4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428066" y="6987037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5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942051" y="6987037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6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367038" y="6987037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7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841585" y="6987037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8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508180" y="6987037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9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717854" y="6627591"/>
            <a:ext cx="2561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1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717854" y="6082420"/>
            <a:ext cx="2561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17854" y="5512468"/>
            <a:ext cx="2561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3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15130" y="4955699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4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15130" y="4370218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5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15130" y="3880803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6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15130" y="3447144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7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15130" y="2976315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8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15130" y="2406364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9</a:t>
            </a:r>
          </a:p>
        </p:txBody>
      </p:sp>
      <p:sp>
        <p:nvSpPr>
          <p:cNvPr id="26" name="TextBox 25"/>
          <p:cNvSpPr txBox="1"/>
          <p:nvPr/>
        </p:nvSpPr>
        <p:spPr>
          <a:xfrm rot="16200000">
            <a:off x="-311712" y="4239860"/>
            <a:ext cx="16015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/>
              <a:t>Setaria</a:t>
            </a:r>
            <a:r>
              <a:rPr lang="en-US" sz="1200" i="1" dirty="0"/>
              <a:t> </a:t>
            </a:r>
            <a:r>
              <a:rPr lang="en-US" sz="1200" i="1" dirty="0" err="1"/>
              <a:t>viridis</a:t>
            </a:r>
            <a:r>
              <a:rPr lang="en-US" sz="1200" i="1" dirty="0"/>
              <a:t> </a:t>
            </a:r>
            <a:r>
              <a:rPr lang="en-US" sz="1200" dirty="0"/>
              <a:t>scaffolds</a:t>
            </a:r>
            <a:endParaRPr lang="en-US" sz="1200" i="1" dirty="0"/>
          </a:p>
        </p:txBody>
      </p:sp>
      <p:pic>
        <p:nvPicPr>
          <p:cNvPr id="27" name="Picture 26" descr="Screen Shot 2020-01-29 at 10.43.33 AM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740" y="2114509"/>
            <a:ext cx="5032742" cy="4902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49578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127</TotalTime>
  <Words>68</Words>
  <Application>Microsoft Macintosh PowerPoint</Application>
  <PresentationFormat>Letter Paper (8.5x11 in)</PresentationFormat>
  <Paragraphs>2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 Lin</dc:creator>
  <cp:lastModifiedBy>Fan Lin</cp:lastModifiedBy>
  <cp:revision>1272</cp:revision>
  <cp:lastPrinted>2020-01-29T19:46:17Z</cp:lastPrinted>
  <dcterms:created xsi:type="dcterms:W3CDTF">2018-04-05T21:34:21Z</dcterms:created>
  <dcterms:modified xsi:type="dcterms:W3CDTF">2020-02-03T04:15:24Z</dcterms:modified>
</cp:coreProperties>
</file>